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150100" cy="94503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FACA5E-827D-4469-9285-BCE2F80834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53FA96-354C-480B-9F62-222C17EB7A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39EA96-E7BB-46B3-BE4B-913671EDE5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D46A2B-6750-49F1-B152-5EAC001736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180105-934F-4978-B64E-DA6E3112F7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C7E6E-6523-493A-9503-E453B83CD5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31C9B3-D93E-4A3E-BEF2-F68F233683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2CE33-BD89-4DBA-A8FF-BB3EBFF6B1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E54741-8ED7-4537-8839-A0C52AF520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ACDAB-66F6-4332-90DF-772B757127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0B4798-5C99-4114-AA33-4D9B399F55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26AC5-D15D-46D8-A9B5-C2A355810A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9D4D5B-BF74-41D2-B796-8F361361D8C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365200" y="684360"/>
          <a:ext cx="6178680" cy="58514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365200" y="684360"/>
                    <a:ext cx="6178680" cy="585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394920" y="69840"/>
            <a:ext cx="8584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ort Dataset Into Pathway-Scoped Sub-Datasets For Further Analysi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77840" y="5464080"/>
            <a:ext cx="20476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List of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athway-scope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b-Dataset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flipV="1">
            <a:off x="1716120" y="5665680"/>
            <a:ext cx="782640" cy="1296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37400" y="3413160"/>
            <a:ext cx="15537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Origina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RI fil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o be sorte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V="1">
            <a:off x="1687680" y="3794040"/>
            <a:ext cx="782640" cy="1296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4-18T03:50:59Z</dcterms:created>
  <dc:creator>Ming Yi</dc:creator>
  <dc:description/>
  <dc:language>en-US</dc:language>
  <cp:lastModifiedBy>Ming Yi</cp:lastModifiedBy>
  <dcterms:modified xsi:type="dcterms:W3CDTF">2005-04-27T15:07:14Z</dcterms:modified>
  <cp:revision>13</cp:revision>
  <dc:subject/>
  <dc:title>Slide 1</dc:title>
</cp:coreProperties>
</file>